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683" r:id="rId2"/>
    <p:sldId id="684" r:id="rId3"/>
    <p:sldId id="687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5956"/>
    <p:restoredTop sz="94635"/>
  </p:normalViewPr>
  <p:slideViewPr>
    <p:cSldViewPr snapToGrid="0" snapToObjects="1">
      <p:cViewPr varScale="1">
        <p:scale>
          <a:sx n="96" d="100"/>
          <a:sy n="96" d="100"/>
        </p:scale>
        <p:origin x="26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7A4641-83A6-D24A-BCBA-E9EB8BB52F8D}" type="datetimeFigureOut">
              <a:rPr lang="en-US" smtClean="0"/>
              <a:t>6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AB7307-A065-E14F-9DBA-297EFDD00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40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793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266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164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474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129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69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066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47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110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303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215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4DB77-D0E6-B04A-9EC3-B1AFFA0AE69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F867D-DB61-3147-A714-0CF147610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56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openxmlformats.org/officeDocument/2006/relationships/image" Target="../media/image7.tiff"/><Relationship Id="rId7" Type="http://schemas.openxmlformats.org/officeDocument/2006/relationships/image" Target="../media/image10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5" Type="http://schemas.openxmlformats.org/officeDocument/2006/relationships/image" Target="../media/image5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A32ADD9-1BC8-B74C-87DE-A312200812F5}"/>
              </a:ext>
            </a:extLst>
          </p:cNvPr>
          <p:cNvSpPr txBox="1"/>
          <p:nvPr/>
        </p:nvSpPr>
        <p:spPr>
          <a:xfrm>
            <a:off x="113643" y="106541"/>
            <a:ext cx="17956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.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07D7EC-95FF-A844-B668-EA92824FB2FA}"/>
              </a:ext>
            </a:extLst>
          </p:cNvPr>
          <p:cNvSpPr txBox="1"/>
          <p:nvPr/>
        </p:nvSpPr>
        <p:spPr>
          <a:xfrm>
            <a:off x="4560614" y="1919632"/>
            <a:ext cx="13388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LU scores 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1D8A7B-F8AD-134A-99BE-B962A411AFDB}"/>
              </a:ext>
            </a:extLst>
          </p:cNvPr>
          <p:cNvSpPr txBox="1"/>
          <p:nvPr/>
        </p:nvSpPr>
        <p:spPr>
          <a:xfrm>
            <a:off x="651065" y="5431891"/>
            <a:ext cx="1933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T gene expression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32C03B-4B21-134F-A75A-DBE21DED6BF5}"/>
              </a:ext>
            </a:extLst>
          </p:cNvPr>
          <p:cNvSpPr txBox="1"/>
          <p:nvPr/>
        </p:nvSpPr>
        <p:spPr>
          <a:xfrm>
            <a:off x="4074700" y="544138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PS1 gene expression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4BFCD5-EFBA-3848-B6D9-51689C485079}"/>
              </a:ext>
            </a:extLst>
          </p:cNvPr>
          <p:cNvSpPr txBox="1"/>
          <p:nvPr/>
        </p:nvSpPr>
        <p:spPr>
          <a:xfrm>
            <a:off x="743969" y="1932597"/>
            <a:ext cx="17556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% Epithelial nuclei</a:t>
            </a:r>
            <a:endParaRPr lang="en-US" sz="14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482BF36-BB17-0F44-B7F2-AC46E15CC0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0232" y="3954735"/>
            <a:ext cx="489896" cy="136942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756F53D-620F-4F44-AC02-A874AA07DD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2720" y="2402478"/>
            <a:ext cx="3291479" cy="153524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C8A7A1C-C325-6241-BFB5-FF0270756B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842" y="5756677"/>
            <a:ext cx="3179995" cy="146769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DA825CA1-F405-A04D-B996-EFC6F2FEA6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0189" y="5737243"/>
            <a:ext cx="3337811" cy="146769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BD2E47D-7A70-8C40-B78F-B0016D1ECB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6217" y="2485390"/>
            <a:ext cx="3199064" cy="13694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7A364FA-E963-464F-B9A0-4881D5F3216A}"/>
              </a:ext>
            </a:extLst>
          </p:cNvPr>
          <p:cNvSpPr txBox="1"/>
          <p:nvPr/>
        </p:nvSpPr>
        <p:spPr>
          <a:xfrm>
            <a:off x="233165" y="988539"/>
            <a:ext cx="65791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umorMap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Batch-corrected Normal Breast Transcriptomes with Epithelial Attribut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85235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A7619B3B-829C-E743-9845-8255F6B559E5}"/>
              </a:ext>
            </a:extLst>
          </p:cNvPr>
          <p:cNvSpPr txBox="1"/>
          <p:nvPr/>
        </p:nvSpPr>
        <p:spPr>
          <a:xfrm>
            <a:off x="4073345" y="4365333"/>
            <a:ext cx="1973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 module 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71BF7A-B60C-3A46-887B-797CB8096F5F}"/>
              </a:ext>
            </a:extLst>
          </p:cNvPr>
          <p:cNvSpPr txBox="1"/>
          <p:nvPr/>
        </p:nvSpPr>
        <p:spPr>
          <a:xfrm>
            <a:off x="1128887" y="6841105"/>
            <a:ext cx="13292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8 module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2A2BA4A-285B-A640-83CE-275E979D8C0D}"/>
              </a:ext>
            </a:extLst>
          </p:cNvPr>
          <p:cNvSpPr txBox="1"/>
          <p:nvPr/>
        </p:nvSpPr>
        <p:spPr>
          <a:xfrm>
            <a:off x="4166891" y="6841105"/>
            <a:ext cx="16733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</a:t>
            </a:r>
            <a:r>
              <a:rPr lang="en-US" sz="1400" b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ell</a:t>
            </a:r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dule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6AC43D-016B-3443-B427-DD1497899D4C}"/>
              </a:ext>
            </a:extLst>
          </p:cNvPr>
          <p:cNvSpPr txBox="1"/>
          <p:nvPr/>
        </p:nvSpPr>
        <p:spPr>
          <a:xfrm>
            <a:off x="1167093" y="1635866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omal nuclei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6E5900A-0456-C548-897A-E7CAB788FB70}"/>
              </a:ext>
            </a:extLst>
          </p:cNvPr>
          <p:cNvSpPr txBox="1"/>
          <p:nvPr/>
        </p:nvSpPr>
        <p:spPr>
          <a:xfrm>
            <a:off x="4089689" y="1567100"/>
            <a:ext cx="1614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ipocyte nuclei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84F500-CD6D-484E-A08D-4B1FBBC06673}"/>
              </a:ext>
            </a:extLst>
          </p:cNvPr>
          <p:cNvSpPr txBox="1"/>
          <p:nvPr/>
        </p:nvSpPr>
        <p:spPr>
          <a:xfrm>
            <a:off x="912481" y="4356291"/>
            <a:ext cx="1545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thelial nuclei</a:t>
            </a:r>
            <a:endParaRPr lang="en-US" sz="14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3053971-AB30-4B4F-824B-1E0D95C70A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1435" y="3272806"/>
            <a:ext cx="465606" cy="101961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58332FD-CA73-054C-AADE-0CA9EC5215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208" y="1959173"/>
            <a:ext cx="2776785" cy="12154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20AFD1E-DC69-BF48-8E2F-6C880B0F2C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4585" y="1959173"/>
            <a:ext cx="2907576" cy="128183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117B66E-A915-C441-961A-85B76B49F6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6840" y="4674644"/>
            <a:ext cx="2856899" cy="122295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2E8D661-1FB4-734C-9434-47E2EA652C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97041" y="4726521"/>
            <a:ext cx="2825949" cy="121546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3214B40-CD9D-5544-80CA-91832086E1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3165" y="7109122"/>
            <a:ext cx="2966828" cy="128183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882ABC0-B614-7140-9F3C-E2B5E56FC60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3558" y="7109122"/>
            <a:ext cx="3030397" cy="131985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A12E51-E552-6646-B758-57157C8A504E}"/>
              </a:ext>
            </a:extLst>
          </p:cNvPr>
          <p:cNvSpPr txBox="1"/>
          <p:nvPr/>
        </p:nvSpPr>
        <p:spPr>
          <a:xfrm>
            <a:off x="113643" y="106541"/>
            <a:ext cx="17956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2.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8D8F2D3-D407-2F44-87DF-A5F0868E74A3}"/>
              </a:ext>
            </a:extLst>
          </p:cNvPr>
          <p:cNvSpPr txBox="1"/>
          <p:nvPr/>
        </p:nvSpPr>
        <p:spPr>
          <a:xfrm>
            <a:off x="233165" y="877165"/>
            <a:ext cx="64829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umorMap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Batch-corrected Normal Breast Transcriptomes with Immune Attribut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060113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24A12E51-E552-6646-B758-57157C8A504E}"/>
              </a:ext>
            </a:extLst>
          </p:cNvPr>
          <p:cNvSpPr txBox="1"/>
          <p:nvPr/>
        </p:nvSpPr>
        <p:spPr>
          <a:xfrm>
            <a:off x="113643" y="106541"/>
            <a:ext cx="17956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.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9670276-0F98-AA4B-8D31-BB223A0139A6}"/>
              </a:ext>
            </a:extLst>
          </p:cNvPr>
          <p:cNvSpPr txBox="1"/>
          <p:nvPr/>
        </p:nvSpPr>
        <p:spPr>
          <a:xfrm>
            <a:off x="139253" y="858068"/>
            <a:ext cx="6579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Adipocyte Activated Gene Expression (P- batch samples)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7B4A604-FD72-2F4D-904B-46D49A1CD5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85291"/>
            <a:ext cx="6858000" cy="4661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2650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65</TotalTime>
  <Words>64</Words>
  <Application>Microsoft Macintosh PowerPoint</Application>
  <PresentationFormat>On-screen Show (4:3)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Benz</dc:creator>
  <cp:lastModifiedBy>Christopher Benz</cp:lastModifiedBy>
  <cp:revision>321</cp:revision>
  <cp:lastPrinted>2020-06-10T13:42:09Z</cp:lastPrinted>
  <dcterms:created xsi:type="dcterms:W3CDTF">2019-04-23T16:01:18Z</dcterms:created>
  <dcterms:modified xsi:type="dcterms:W3CDTF">2020-06-10T15:59:51Z</dcterms:modified>
</cp:coreProperties>
</file>